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4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NULL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NULL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NULL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NULL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err="1"/>
              <a:t>Lenvatinib+pembrolizumab</a:t>
            </a:r>
            <a:endParaRPr lang="en-US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6.5335958005249384E-2"/>
          <c:y val="0.12626359758127662"/>
          <c:w val="0.70674035937815805"/>
          <c:h val="0.74598471651220877"/>
        </c:manualLayout>
      </c:layout>
      <c:scatterChart>
        <c:scatterStyle val="lineMarker"/>
        <c:varyColors val="0"/>
        <c:ser>
          <c:idx val="0"/>
          <c:order val="0"/>
          <c:tx>
            <c:v>Trial OS</c:v>
          </c:tx>
          <c:spPr>
            <a:ln w="28575">
              <a:solidFill>
                <a:schemeClr val="accent1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F$34:$F$58</c:f>
              <c:numCache>
                <c:formatCode>General</c:formatCode>
                <c:ptCount val="25"/>
                <c:pt idx="0">
                  <c:v>1</c:v>
                </c:pt>
                <c:pt idx="1">
                  <c:v>0.99</c:v>
                </c:pt>
                <c:pt idx="2">
                  <c:v>0.96</c:v>
                </c:pt>
                <c:pt idx="3">
                  <c:v>0.93</c:v>
                </c:pt>
                <c:pt idx="4">
                  <c:v>0.9</c:v>
                </c:pt>
                <c:pt idx="5">
                  <c:v>0.87</c:v>
                </c:pt>
                <c:pt idx="6">
                  <c:v>0.81</c:v>
                </c:pt>
                <c:pt idx="7">
                  <c:v>0.77</c:v>
                </c:pt>
                <c:pt idx="8">
                  <c:v>0.73</c:v>
                </c:pt>
                <c:pt idx="9">
                  <c:v>0.71</c:v>
                </c:pt>
                <c:pt idx="10">
                  <c:v>0.68</c:v>
                </c:pt>
                <c:pt idx="11">
                  <c:v>0.65</c:v>
                </c:pt>
                <c:pt idx="12">
                  <c:v>0.62</c:v>
                </c:pt>
                <c:pt idx="13">
                  <c:v>0.59</c:v>
                </c:pt>
                <c:pt idx="14">
                  <c:v>0.56999999999999995</c:v>
                </c:pt>
                <c:pt idx="15">
                  <c:v>0.55000000000000004</c:v>
                </c:pt>
                <c:pt idx="16">
                  <c:v>0.54</c:v>
                </c:pt>
                <c:pt idx="17">
                  <c:v>0.53</c:v>
                </c:pt>
                <c:pt idx="18">
                  <c:v>0.51</c:v>
                </c:pt>
                <c:pt idx="19">
                  <c:v>0.48</c:v>
                </c:pt>
                <c:pt idx="20">
                  <c:v>0.45</c:v>
                </c:pt>
                <c:pt idx="21">
                  <c:v>0.43</c:v>
                </c:pt>
                <c:pt idx="22">
                  <c:v>0.42</c:v>
                </c:pt>
                <c:pt idx="23">
                  <c:v>0.42</c:v>
                </c:pt>
                <c:pt idx="24">
                  <c:v>0.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E2A-4D12-B72E-7AF4DD52A7C1}"/>
            </c:ext>
          </c:extLst>
        </c:ser>
        <c:ser>
          <c:idx val="1"/>
          <c:order val="1"/>
          <c:tx>
            <c:v>Model OS</c:v>
          </c:tx>
          <c:spPr>
            <a:ln w="28575">
              <a:solidFill>
                <a:srgbClr val="002060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G$34:$G$58</c:f>
              <c:numCache>
                <c:formatCode>General</c:formatCode>
                <c:ptCount val="25"/>
                <c:pt idx="0">
                  <c:v>1</c:v>
                </c:pt>
                <c:pt idx="1">
                  <c:v>0.96705023853618099</c:v>
                </c:pt>
                <c:pt idx="2">
                  <c:v>0.93433700235942663</c:v>
                </c:pt>
                <c:pt idx="3">
                  <c:v>0.90196669412223884</c:v>
                </c:pt>
                <c:pt idx="4">
                  <c:v>0.87003041521267777</c:v>
                </c:pt>
                <c:pt idx="5">
                  <c:v>0.83860557716827788</c:v>
                </c:pt>
                <c:pt idx="6">
                  <c:v>0.80775736056794012</c:v>
                </c:pt>
                <c:pt idx="7">
                  <c:v>0.77754003515389614</c:v>
                </c:pt>
                <c:pt idx="8">
                  <c:v>0.74799815372620682</c:v>
                </c:pt>
                <c:pt idx="9">
                  <c:v>0.7191676312476214</c:v>
                </c:pt>
                <c:pt idx="10">
                  <c:v>0.69107671958792483</c:v>
                </c:pt>
                <c:pt idx="11">
                  <c:v>0.66374688741587562</c:v>
                </c:pt>
                <c:pt idx="12">
                  <c:v>0.63719361390592832</c:v>
                </c:pt>
                <c:pt idx="13">
                  <c:v>0.61142710415922819</c:v>
                </c:pt>
                <c:pt idx="14">
                  <c:v>0.58645293353754757</c:v>
                </c:pt>
                <c:pt idx="15">
                  <c:v>0.56227262746912332</c:v>
                </c:pt>
                <c:pt idx="16">
                  <c:v>0.53888418270148275</c:v>
                </c:pt>
                <c:pt idx="17">
                  <c:v>0.51628253544347702</c:v>
                </c:pt>
                <c:pt idx="18">
                  <c:v>0.49445998135247382</c:v>
                </c:pt>
                <c:pt idx="19">
                  <c:v>0.47340655187895442</c:v>
                </c:pt>
                <c:pt idx="20">
                  <c:v>0.45311035107594272</c:v>
                </c:pt>
                <c:pt idx="21">
                  <c:v>0.43355785661138324</c:v>
                </c:pt>
                <c:pt idx="22">
                  <c:v>0.41473418838471343</c:v>
                </c:pt>
                <c:pt idx="23">
                  <c:v>0.3966233478416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E2A-4D12-B72E-7AF4DD52A7C1}"/>
            </c:ext>
          </c:extLst>
        </c:ser>
        <c:ser>
          <c:idx val="2"/>
          <c:order val="2"/>
          <c:tx>
            <c:v>Trial PFS</c:v>
          </c:tx>
          <c:spPr>
            <a:ln w="28575">
              <a:solidFill>
                <a:schemeClr val="accent2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I$34:$I$58</c:f>
              <c:numCache>
                <c:formatCode>General</c:formatCode>
                <c:ptCount val="25"/>
                <c:pt idx="0">
                  <c:v>1</c:v>
                </c:pt>
                <c:pt idx="1">
                  <c:v>0.97</c:v>
                </c:pt>
                <c:pt idx="2">
                  <c:v>0.85</c:v>
                </c:pt>
                <c:pt idx="3">
                  <c:v>0.8</c:v>
                </c:pt>
                <c:pt idx="4">
                  <c:v>0.67</c:v>
                </c:pt>
                <c:pt idx="5">
                  <c:v>0.63</c:v>
                </c:pt>
                <c:pt idx="6">
                  <c:v>0.53</c:v>
                </c:pt>
                <c:pt idx="7">
                  <c:v>0.51</c:v>
                </c:pt>
                <c:pt idx="8">
                  <c:v>0.42</c:v>
                </c:pt>
                <c:pt idx="9">
                  <c:v>0.41</c:v>
                </c:pt>
                <c:pt idx="10">
                  <c:v>0.36</c:v>
                </c:pt>
                <c:pt idx="11">
                  <c:v>0.34</c:v>
                </c:pt>
                <c:pt idx="12">
                  <c:v>0.31</c:v>
                </c:pt>
                <c:pt idx="13">
                  <c:v>0.3</c:v>
                </c:pt>
                <c:pt idx="14">
                  <c:v>0.27</c:v>
                </c:pt>
                <c:pt idx="15">
                  <c:v>0.26</c:v>
                </c:pt>
                <c:pt idx="16">
                  <c:v>0.26</c:v>
                </c:pt>
                <c:pt idx="17">
                  <c:v>0.25</c:v>
                </c:pt>
                <c:pt idx="18">
                  <c:v>0.25</c:v>
                </c:pt>
                <c:pt idx="19">
                  <c:v>0.22</c:v>
                </c:pt>
                <c:pt idx="20">
                  <c:v>0.22</c:v>
                </c:pt>
                <c:pt idx="21">
                  <c:v>0.21</c:v>
                </c:pt>
                <c:pt idx="22">
                  <c:v>0.21</c:v>
                </c:pt>
                <c:pt idx="23">
                  <c:v>0.21</c:v>
                </c:pt>
                <c:pt idx="24">
                  <c:v>0.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E2A-4D12-B72E-7AF4DD52A7C1}"/>
            </c:ext>
          </c:extLst>
        </c:ser>
        <c:ser>
          <c:idx val="3"/>
          <c:order val="3"/>
          <c:tx>
            <c:v>Model PFS</c:v>
          </c:tx>
          <c:spPr>
            <a:ln w="28575">
              <a:solidFill>
                <a:schemeClr val="accent2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J$34:$J$58</c:f>
              <c:numCache>
                <c:formatCode>General</c:formatCode>
                <c:ptCount val="25"/>
                <c:pt idx="0">
                  <c:v>1</c:v>
                </c:pt>
                <c:pt idx="1">
                  <c:v>0.9146848123287914</c:v>
                </c:pt>
                <c:pt idx="2">
                  <c:v>0.83664830590495642</c:v>
                </c:pt>
                <c:pt idx="3">
                  <c:v>0.76526949867187644</c:v>
                </c:pt>
                <c:pt idx="4">
                  <c:v>0.69998038777363358</c:v>
                </c:pt>
                <c:pt idx="5">
                  <c:v>0.64026142962456067</c:v>
                </c:pt>
                <c:pt idx="6">
                  <c:v>0.58563740559750499</c:v>
                </c:pt>
                <c:pt idx="7">
                  <c:v>0.5356736404316742</c:v>
                </c:pt>
                <c:pt idx="8">
                  <c:v>0.48997254326772638</c:v>
                </c:pt>
                <c:pt idx="9">
                  <c:v>0.44817044378510096</c:v>
                </c:pt>
                <c:pt idx="10">
                  <c:v>0.40993469826488621</c:v>
                </c:pt>
                <c:pt idx="11">
                  <c:v>0.37496104254947715</c:v>
                </c:pt>
                <c:pt idx="12">
                  <c:v>0.34297117083497647</c:v>
                </c:pt>
                <c:pt idx="13">
                  <c:v>0.3137105210293763</c:v>
                </c:pt>
                <c:pt idx="14">
                  <c:v>0.28694624905332239</c:v>
                </c:pt>
                <c:pt idx="15">
                  <c:v>0.26246537596378883</c:v>
                </c:pt>
                <c:pt idx="16">
                  <c:v>0.24007309315624387</c:v>
                </c:pt>
                <c:pt idx="17">
                  <c:v>0.21959121215881136</c:v>
                </c:pt>
                <c:pt idx="18">
                  <c:v>0.2008567466825342</c:v>
                </c:pt>
                <c:pt idx="19">
                  <c:v>0.18372061564428538</c:v>
                </c:pt>
                <c:pt idx="20">
                  <c:v>0.1680464568415232</c:v>
                </c:pt>
                <c:pt idx="21">
                  <c:v>0.15370954183860699</c:v>
                </c:pt>
                <c:pt idx="22">
                  <c:v>0.14059578342979076</c:v>
                </c:pt>
                <c:pt idx="23">
                  <c:v>0.128600827780697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E2A-4D12-B72E-7AF4DD52A7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7534416"/>
        <c:axId val="367535592"/>
      </c:scatterChart>
      <c:valAx>
        <c:axId val="367534416"/>
        <c:scaling>
          <c:orientation val="minMax"/>
          <c:max val="28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dirty="0"/>
                  <a:t>Months</a:t>
                </a:r>
                <a:endParaRPr lang="zh-CN" altLang="en-US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2060"/>
            </a:solidFill>
          </a:ln>
        </c:spPr>
        <c:crossAx val="367535592"/>
        <c:crossesAt val="0"/>
        <c:crossBetween val="midCat"/>
      </c:valAx>
      <c:valAx>
        <c:axId val="36753559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3675344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8609968360608262"/>
          <c:y val="0.38368158927957535"/>
          <c:w val="0.15956541764429061"/>
          <c:h val="0.2822664246809689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Chemotherapy</a:t>
            </a:r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6.5335958005249384E-2"/>
          <c:y val="0.12626359758127662"/>
          <c:w val="0.70674035937815805"/>
          <c:h val="0.74598471651220877"/>
        </c:manualLayout>
      </c:layout>
      <c:scatterChart>
        <c:scatterStyle val="lineMarker"/>
        <c:varyColors val="0"/>
        <c:ser>
          <c:idx val="0"/>
          <c:order val="0"/>
          <c:tx>
            <c:v>Trial OS</c:v>
          </c:tx>
          <c:spPr>
            <a:ln w="28575">
              <a:solidFill>
                <a:schemeClr val="accent1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F$34:$F$58</c:f>
              <c:numCache>
                <c:formatCode>General</c:formatCode>
                <c:ptCount val="25"/>
                <c:pt idx="0">
                  <c:v>1</c:v>
                </c:pt>
                <c:pt idx="1">
                  <c:v>0.99</c:v>
                </c:pt>
                <c:pt idx="2">
                  <c:v>0.96</c:v>
                </c:pt>
                <c:pt idx="3">
                  <c:v>0.92</c:v>
                </c:pt>
                <c:pt idx="4">
                  <c:v>0.85</c:v>
                </c:pt>
                <c:pt idx="5">
                  <c:v>0.8</c:v>
                </c:pt>
                <c:pt idx="6">
                  <c:v>0.75</c:v>
                </c:pt>
                <c:pt idx="7">
                  <c:v>0.68</c:v>
                </c:pt>
                <c:pt idx="8">
                  <c:v>0.64</c:v>
                </c:pt>
                <c:pt idx="9">
                  <c:v>0.6</c:v>
                </c:pt>
                <c:pt idx="10">
                  <c:v>0.56999999999999995</c:v>
                </c:pt>
                <c:pt idx="11">
                  <c:v>0.52</c:v>
                </c:pt>
                <c:pt idx="12">
                  <c:v>0.48</c:v>
                </c:pt>
                <c:pt idx="13">
                  <c:v>0.44</c:v>
                </c:pt>
                <c:pt idx="14">
                  <c:v>0.41</c:v>
                </c:pt>
                <c:pt idx="15">
                  <c:v>0.37</c:v>
                </c:pt>
                <c:pt idx="16">
                  <c:v>0.36</c:v>
                </c:pt>
                <c:pt idx="17">
                  <c:v>0.31</c:v>
                </c:pt>
                <c:pt idx="18">
                  <c:v>0.28000000000000003</c:v>
                </c:pt>
                <c:pt idx="19">
                  <c:v>0.28000000000000003</c:v>
                </c:pt>
                <c:pt idx="20">
                  <c:v>0.27</c:v>
                </c:pt>
                <c:pt idx="21">
                  <c:v>0.26</c:v>
                </c:pt>
                <c:pt idx="22">
                  <c:v>0.22</c:v>
                </c:pt>
                <c:pt idx="23">
                  <c:v>0.21</c:v>
                </c:pt>
                <c:pt idx="24">
                  <c:v>0.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C89-4347-B866-E4B71C9BD4CB}"/>
            </c:ext>
          </c:extLst>
        </c:ser>
        <c:ser>
          <c:idx val="1"/>
          <c:order val="1"/>
          <c:tx>
            <c:v>Model OS</c:v>
          </c:tx>
          <c:spPr>
            <a:ln w="28575">
              <a:solidFill>
                <a:srgbClr val="002060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G$34:$G$58</c:f>
              <c:numCache>
                <c:formatCode>General</c:formatCode>
                <c:ptCount val="25"/>
                <c:pt idx="0">
                  <c:v>1</c:v>
                </c:pt>
                <c:pt idx="1">
                  <c:v>0.96889922161600062</c:v>
                </c:pt>
                <c:pt idx="2">
                  <c:v>0.9310694330594036</c:v>
                </c:pt>
                <c:pt idx="3">
                  <c:v>0.88864383508365818</c:v>
                </c:pt>
                <c:pt idx="4">
                  <c:v>0.84331996315455726</c:v>
                </c:pt>
                <c:pt idx="5">
                  <c:v>0.79643765648877962</c:v>
                </c:pt>
                <c:pt idx="6">
                  <c:v>0.74904385501537896</c:v>
                </c:pt>
                <c:pt idx="7">
                  <c:v>0.7019463861997095</c:v>
                </c:pt>
                <c:pt idx="8">
                  <c:v>0.65575855426766383</c:v>
                </c:pt>
                <c:pt idx="9">
                  <c:v>0.61093605095439085</c:v>
                </c:pt>
                <c:pt idx="10">
                  <c:v>0.56780746054754194</c:v>
                </c:pt>
                <c:pt idx="11">
                  <c:v>0.52659942519208336</c:v>
                </c:pt>
                <c:pt idx="12">
                  <c:v>0.48745736285781938</c:v>
                </c:pt>
                <c:pt idx="13">
                  <c:v>0.45046248473272088</c:v>
                </c:pt>
                <c:pt idx="14">
                  <c:v>0.41564573663083898</c:v>
                </c:pt>
                <c:pt idx="15">
                  <c:v>0.38299918653980347</c:v>
                </c:pt>
                <c:pt idx="16">
                  <c:v>0.35248529452434307</c:v>
                </c:pt>
                <c:pt idx="17">
                  <c:v>0.32404442919654147</c:v>
                </c:pt>
                <c:pt idx="18">
                  <c:v>0.2976009346311832</c:v>
                </c:pt>
                <c:pt idx="19">
                  <c:v>0.27306800107176782</c:v>
                </c:pt>
                <c:pt idx="20">
                  <c:v>0.2503515504649122</c:v>
                </c:pt>
                <c:pt idx="21">
                  <c:v>0.22935331245474519</c:v>
                </c:pt>
                <c:pt idx="22">
                  <c:v>0.20997323685283648</c:v>
                </c:pt>
                <c:pt idx="23">
                  <c:v>0.192111363839310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C89-4347-B866-E4B71C9BD4CB}"/>
            </c:ext>
          </c:extLst>
        </c:ser>
        <c:ser>
          <c:idx val="2"/>
          <c:order val="2"/>
          <c:tx>
            <c:v>Trial PFS</c:v>
          </c:tx>
          <c:spPr>
            <a:ln w="28575">
              <a:solidFill>
                <a:schemeClr val="accent2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I$34:$I$58</c:f>
              <c:numCache>
                <c:formatCode>General</c:formatCode>
                <c:ptCount val="25"/>
                <c:pt idx="0">
                  <c:v>1</c:v>
                </c:pt>
                <c:pt idx="1">
                  <c:v>0.97</c:v>
                </c:pt>
                <c:pt idx="2">
                  <c:v>0.72</c:v>
                </c:pt>
                <c:pt idx="3">
                  <c:v>0.62</c:v>
                </c:pt>
                <c:pt idx="4">
                  <c:v>0.46</c:v>
                </c:pt>
                <c:pt idx="5">
                  <c:v>0.43</c:v>
                </c:pt>
                <c:pt idx="6">
                  <c:v>0.34</c:v>
                </c:pt>
                <c:pt idx="7">
                  <c:v>0.28999999999999998</c:v>
                </c:pt>
                <c:pt idx="8">
                  <c:v>0.21</c:v>
                </c:pt>
                <c:pt idx="9">
                  <c:v>0.18</c:v>
                </c:pt>
                <c:pt idx="10">
                  <c:v>0.14000000000000001</c:v>
                </c:pt>
                <c:pt idx="11">
                  <c:v>0.14000000000000001</c:v>
                </c:pt>
                <c:pt idx="12">
                  <c:v>0.13</c:v>
                </c:pt>
                <c:pt idx="13">
                  <c:v>0.12</c:v>
                </c:pt>
                <c:pt idx="14">
                  <c:v>0.11</c:v>
                </c:pt>
                <c:pt idx="15">
                  <c:v>0.1</c:v>
                </c:pt>
                <c:pt idx="16">
                  <c:v>0.09</c:v>
                </c:pt>
                <c:pt idx="17">
                  <c:v>0.08</c:v>
                </c:pt>
                <c:pt idx="18">
                  <c:v>0.08</c:v>
                </c:pt>
                <c:pt idx="19">
                  <c:v>0.04</c:v>
                </c:pt>
                <c:pt idx="20">
                  <c:v>0.04</c:v>
                </c:pt>
                <c:pt idx="21">
                  <c:v>0.04</c:v>
                </c:pt>
                <c:pt idx="22">
                  <c:v>0.04</c:v>
                </c:pt>
                <c:pt idx="23">
                  <c:v>0.04</c:v>
                </c:pt>
                <c:pt idx="24">
                  <c:v>0.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C89-4347-B866-E4B71C9BD4CB}"/>
            </c:ext>
          </c:extLst>
        </c:ser>
        <c:ser>
          <c:idx val="3"/>
          <c:order val="3"/>
          <c:tx>
            <c:v>Model PFS</c:v>
          </c:tx>
          <c:spPr>
            <a:ln w="28575">
              <a:solidFill>
                <a:schemeClr val="accent2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J$34:$J$58</c:f>
              <c:numCache>
                <c:formatCode>General</c:formatCode>
                <c:ptCount val="25"/>
                <c:pt idx="0">
                  <c:v>1</c:v>
                </c:pt>
                <c:pt idx="1">
                  <c:v>0.84155728577451516</c:v>
                </c:pt>
                <c:pt idx="2">
                  <c:v>0.70821866524016897</c:v>
                </c:pt>
                <c:pt idx="3">
                  <c:v>0.5960065776543666</c:v>
                </c:pt>
                <c:pt idx="4">
                  <c:v>0.50157367779456652</c:v>
                </c:pt>
                <c:pt idx="5">
                  <c:v>0.42210298290073661</c:v>
                </c:pt>
                <c:pt idx="6">
                  <c:v>0.35522384060727052</c:v>
                </c:pt>
                <c:pt idx="7">
                  <c:v>0.29894121114385358</c:v>
                </c:pt>
                <c:pt idx="8">
                  <c:v>0.2515761542563677</c:v>
                </c:pt>
                <c:pt idx="9">
                  <c:v>0.21171574554157957</c:v>
                </c:pt>
                <c:pt idx="10">
                  <c:v>0.17817092817369962</c:v>
                </c:pt>
                <c:pt idx="11">
                  <c:v>0.14994104271778474</c:v>
                </c:pt>
                <c:pt idx="12">
                  <c:v>0.12618397693577957</c:v>
                </c:pt>
                <c:pt idx="13">
                  <c:v>0.10619104513830868</c:v>
                </c:pt>
                <c:pt idx="14">
                  <c:v>8.9365847720154087E-2</c:v>
                </c:pt>
                <c:pt idx="15">
                  <c:v>7.520648024831153E-2</c:v>
                </c:pt>
                <c:pt idx="16">
                  <c:v>6.3290561390423744E-2</c:v>
                </c:pt>
                <c:pt idx="17">
                  <c:v>5.3262633058870336E-2</c:v>
                </c:pt>
                <c:pt idx="18">
                  <c:v>4.4823556910226887E-2</c:v>
                </c:pt>
                <c:pt idx="19">
                  <c:v>3.7721590892130057E-2</c:v>
                </c:pt>
                <c:pt idx="20">
                  <c:v>3.1744879646277646E-2</c:v>
                </c:pt>
                <c:pt idx="21">
                  <c:v>2.6715134752360068E-2</c:v>
                </c:pt>
                <c:pt idx="22">
                  <c:v>2.2482316291296565E-2</c:v>
                </c:pt>
                <c:pt idx="23">
                  <c:v>1.892015707602770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C89-4347-B866-E4B71C9BD4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7534416"/>
        <c:axId val="367535592"/>
      </c:scatterChart>
      <c:valAx>
        <c:axId val="367534416"/>
        <c:scaling>
          <c:orientation val="minMax"/>
          <c:max val="28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dirty="0"/>
                  <a:t>Months</a:t>
                </a:r>
                <a:endParaRPr lang="zh-CN" altLang="en-US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367535592"/>
        <c:crossesAt val="0"/>
        <c:crossBetween val="midCat"/>
      </c:valAx>
      <c:valAx>
        <c:axId val="36753559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3675344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81089546538182955"/>
          <c:y val="0.3612671225977836"/>
          <c:w val="0.15768834213536437"/>
          <c:h val="0.2845953338887991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algn="ctr" rtl="0">
              <a:defRPr/>
            </a:pPr>
            <a:r>
              <a:rPr lang="en-US"/>
              <a:t>Lenvatinib+pembrolizumab</a:t>
            </a:r>
            <a:endParaRPr lang="zh-CN"/>
          </a:p>
          <a:p>
            <a:pPr algn="ctr" rtl="0">
              <a:defRPr/>
            </a:pPr>
            <a:endParaRPr lang="en-US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6.5335958005249384E-2"/>
          <c:y val="0.12626359758127662"/>
          <c:w val="0.70674035937815805"/>
          <c:h val="0.74598471651220877"/>
        </c:manualLayout>
      </c:layout>
      <c:scatterChart>
        <c:scatterStyle val="lineMarker"/>
        <c:varyColors val="0"/>
        <c:ser>
          <c:idx val="0"/>
          <c:order val="0"/>
          <c:tx>
            <c:v>Trial OS</c:v>
          </c:tx>
          <c:spPr>
            <a:ln w="28575">
              <a:solidFill>
                <a:schemeClr val="accent1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F$34:$F$58</c:f>
              <c:numCache>
                <c:formatCode>General</c:formatCode>
                <c:ptCount val="25"/>
                <c:pt idx="0">
                  <c:v>1</c:v>
                </c:pt>
                <c:pt idx="1">
                  <c:v>0.99</c:v>
                </c:pt>
                <c:pt idx="2">
                  <c:v>0.96</c:v>
                </c:pt>
                <c:pt idx="3">
                  <c:v>0.93</c:v>
                </c:pt>
                <c:pt idx="4">
                  <c:v>0.9</c:v>
                </c:pt>
                <c:pt idx="5">
                  <c:v>0.87</c:v>
                </c:pt>
                <c:pt idx="6">
                  <c:v>0.83</c:v>
                </c:pt>
                <c:pt idx="7">
                  <c:v>0.77</c:v>
                </c:pt>
                <c:pt idx="8">
                  <c:v>0.72</c:v>
                </c:pt>
                <c:pt idx="9">
                  <c:v>0.7</c:v>
                </c:pt>
                <c:pt idx="10">
                  <c:v>0.66</c:v>
                </c:pt>
                <c:pt idx="11">
                  <c:v>0.64</c:v>
                </c:pt>
                <c:pt idx="12">
                  <c:v>0.61</c:v>
                </c:pt>
                <c:pt idx="13">
                  <c:v>0.57999999999999996</c:v>
                </c:pt>
                <c:pt idx="14">
                  <c:v>0.56000000000000005</c:v>
                </c:pt>
                <c:pt idx="15">
                  <c:v>0.54</c:v>
                </c:pt>
                <c:pt idx="16">
                  <c:v>0.53</c:v>
                </c:pt>
                <c:pt idx="17">
                  <c:v>0.51</c:v>
                </c:pt>
                <c:pt idx="18">
                  <c:v>0.48</c:v>
                </c:pt>
                <c:pt idx="19">
                  <c:v>0.45</c:v>
                </c:pt>
                <c:pt idx="20">
                  <c:v>0.41</c:v>
                </c:pt>
                <c:pt idx="21">
                  <c:v>0.39</c:v>
                </c:pt>
                <c:pt idx="22">
                  <c:v>0.37</c:v>
                </c:pt>
                <c:pt idx="23">
                  <c:v>0.37</c:v>
                </c:pt>
                <c:pt idx="24">
                  <c:v>0.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DB9-476C-81E0-E302B2A6EE02}"/>
            </c:ext>
          </c:extLst>
        </c:ser>
        <c:ser>
          <c:idx val="1"/>
          <c:order val="1"/>
          <c:tx>
            <c:v>Model OS</c:v>
          </c:tx>
          <c:spPr>
            <a:ln w="28575">
              <a:solidFill>
                <a:srgbClr val="002060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G$34:$G$58</c:f>
              <c:numCache>
                <c:formatCode>General</c:formatCode>
                <c:ptCount val="25"/>
                <c:pt idx="0">
                  <c:v>1</c:v>
                </c:pt>
                <c:pt idx="1">
                  <c:v>0.97099272856334917</c:v>
                </c:pt>
                <c:pt idx="2">
                  <c:v>0.94060026847478373</c:v>
                </c:pt>
                <c:pt idx="3">
                  <c:v>0.90921398854348501</c:v>
                </c:pt>
                <c:pt idx="4">
                  <c:v>0.87717178576689658</c:v>
                </c:pt>
                <c:pt idx="5">
                  <c:v>0.84476418639987583</c:v>
                </c:pt>
                <c:pt idx="6">
                  <c:v>0.81223980345189095</c:v>
                </c:pt>
                <c:pt idx="7">
                  <c:v>0.77981021575427101</c:v>
                </c:pt>
                <c:pt idx="8">
                  <c:v>0.74765432730098735</c:v>
                </c:pt>
                <c:pt idx="9">
                  <c:v>0.71592225975517199</c:v>
                </c:pt>
                <c:pt idx="10">
                  <c:v>0.68473882576896883</c:v>
                </c:pt>
                <c:pt idx="11">
                  <c:v>0.65420662603166324</c:v>
                </c:pt>
                <c:pt idx="12">
                  <c:v>0.62440880869082971</c:v>
                </c:pt>
                <c:pt idx="13">
                  <c:v>0.59541152593875846</c:v>
                </c:pt>
                <c:pt idx="14">
                  <c:v>0.56726611908123692</c:v>
                </c:pt>
                <c:pt idx="15">
                  <c:v>0.5400110602713174</c:v>
                </c:pt>
                <c:pt idx="16">
                  <c:v>0.51367367626397553</c:v>
                </c:pt>
                <c:pt idx="17">
                  <c:v>0.48827167699870078</c:v>
                </c:pt>
                <c:pt idx="18">
                  <c:v>0.46381450951908243</c:v>
                </c:pt>
                <c:pt idx="19">
                  <c:v>0.44030455566698246</c:v>
                </c:pt>
                <c:pt idx="20">
                  <c:v>0.41773819012189811</c:v>
                </c:pt>
                <c:pt idx="21">
                  <c:v>0.39610671367369704</c:v>
                </c:pt>
                <c:pt idx="22">
                  <c:v>0.37539717510108178</c:v>
                </c:pt>
                <c:pt idx="23">
                  <c:v>0.35559309366265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DB9-476C-81E0-E302B2A6EE02}"/>
            </c:ext>
          </c:extLst>
        </c:ser>
        <c:ser>
          <c:idx val="2"/>
          <c:order val="2"/>
          <c:tx>
            <c:v>Trial PFS</c:v>
          </c:tx>
          <c:spPr>
            <a:ln w="28575">
              <a:solidFill>
                <a:schemeClr val="accent2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I$34:$I$58</c:f>
              <c:numCache>
                <c:formatCode>General</c:formatCode>
                <c:ptCount val="25"/>
                <c:pt idx="0">
                  <c:v>1</c:v>
                </c:pt>
                <c:pt idx="1">
                  <c:v>0.97</c:v>
                </c:pt>
                <c:pt idx="2">
                  <c:v>0.84</c:v>
                </c:pt>
                <c:pt idx="3">
                  <c:v>0.79</c:v>
                </c:pt>
                <c:pt idx="4">
                  <c:v>0.65</c:v>
                </c:pt>
                <c:pt idx="5">
                  <c:v>0.62</c:v>
                </c:pt>
                <c:pt idx="6">
                  <c:v>0.52</c:v>
                </c:pt>
                <c:pt idx="7">
                  <c:v>0.49</c:v>
                </c:pt>
                <c:pt idx="8">
                  <c:v>0.39</c:v>
                </c:pt>
                <c:pt idx="9">
                  <c:v>0.37</c:v>
                </c:pt>
                <c:pt idx="10">
                  <c:v>0.33</c:v>
                </c:pt>
                <c:pt idx="11">
                  <c:v>0.31</c:v>
                </c:pt>
                <c:pt idx="12">
                  <c:v>0.27</c:v>
                </c:pt>
                <c:pt idx="13">
                  <c:v>0.24</c:v>
                </c:pt>
                <c:pt idx="14">
                  <c:v>0.23</c:v>
                </c:pt>
                <c:pt idx="15">
                  <c:v>0.21</c:v>
                </c:pt>
                <c:pt idx="16">
                  <c:v>0.21</c:v>
                </c:pt>
                <c:pt idx="17">
                  <c:v>0.21</c:v>
                </c:pt>
                <c:pt idx="18">
                  <c:v>0.21</c:v>
                </c:pt>
                <c:pt idx="19">
                  <c:v>0.19</c:v>
                </c:pt>
                <c:pt idx="20">
                  <c:v>0.17</c:v>
                </c:pt>
                <c:pt idx="21">
                  <c:v>0.17</c:v>
                </c:pt>
                <c:pt idx="22">
                  <c:v>0.17</c:v>
                </c:pt>
                <c:pt idx="23">
                  <c:v>0.17</c:v>
                </c:pt>
                <c:pt idx="24">
                  <c:v>0.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DB9-476C-81E0-E302B2A6EE02}"/>
            </c:ext>
          </c:extLst>
        </c:ser>
        <c:ser>
          <c:idx val="3"/>
          <c:order val="3"/>
          <c:tx>
            <c:v>Model PFS</c:v>
          </c:tx>
          <c:spPr>
            <a:ln w="28575">
              <a:solidFill>
                <a:schemeClr val="accent2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J$34:$J$58</c:f>
              <c:numCache>
                <c:formatCode>General</c:formatCode>
                <c:ptCount val="25"/>
                <c:pt idx="0">
                  <c:v>1</c:v>
                </c:pt>
                <c:pt idx="1">
                  <c:v>0.905049652308485</c:v>
                </c:pt>
                <c:pt idx="2">
                  <c:v>0.81911487314370957</c:v>
                </c:pt>
                <c:pt idx="3">
                  <c:v>0.74133963113942314</c:v>
                </c:pt>
                <c:pt idx="4">
                  <c:v>0.67094917540523547</c:v>
                </c:pt>
                <c:pt idx="5">
                  <c:v>0.60724231791717309</c:v>
                </c:pt>
                <c:pt idx="6">
                  <c:v>0.54958444869793599</c:v>
                </c:pt>
                <c:pt idx="7">
                  <c:v>0.49740121420821737</c:v>
                </c:pt>
                <c:pt idx="8">
                  <c:v>0.45017279597696536</c:v>
                </c:pt>
                <c:pt idx="9">
                  <c:v>0.40742873247769107</c:v>
                </c:pt>
                <c:pt idx="10">
                  <c:v>0.36874323266942105</c:v>
                </c:pt>
                <c:pt idx="11">
                  <c:v>0.33373093451856628</c:v>
                </c:pt>
                <c:pt idx="12">
                  <c:v>0.30204306625061417</c:v>
                </c:pt>
                <c:pt idx="13">
                  <c:v>0.27336397209230706</c:v>
                </c:pt>
                <c:pt idx="14">
                  <c:v>0.24740796789580891</c:v>
                </c:pt>
                <c:pt idx="15">
                  <c:v>0.22391649532245067</c:v>
                </c:pt>
                <c:pt idx="16">
                  <c:v>0.20265554623771848</c:v>
                </c:pt>
                <c:pt idx="17">
                  <c:v>0.18341333166083321</c:v>
                </c:pt>
                <c:pt idx="18">
                  <c:v>0.16599817204837794</c:v>
                </c:pt>
                <c:pt idx="19">
                  <c:v>0.15023658789622851</c:v>
                </c:pt>
                <c:pt idx="20">
                  <c:v>0.13597157163949475</c:v>
                </c:pt>
                <c:pt idx="21">
                  <c:v>0.12306102363616296</c:v>
                </c:pt>
                <c:pt idx="22">
                  <c:v>0.11137633665463555</c:v>
                </c:pt>
                <c:pt idx="23">
                  <c:v>0.100801114764670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DB9-476C-81E0-E302B2A6EE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7534416"/>
        <c:axId val="367535592"/>
      </c:scatterChart>
      <c:valAx>
        <c:axId val="367534416"/>
        <c:scaling>
          <c:orientation val="minMax"/>
          <c:max val="28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onths</a:t>
                </a:r>
                <a:endParaRPr lang="zh-CN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367535592"/>
        <c:crossesAt val="0"/>
        <c:crossBetween val="midCat"/>
      </c:valAx>
      <c:valAx>
        <c:axId val="36753559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3675344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81216317170547325"/>
          <c:y val="0.35049043323370843"/>
          <c:w val="0.1697951110853034"/>
          <c:h val="0.30998243583937657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algn="ctr" rtl="0">
              <a:defRPr/>
            </a:pPr>
            <a:r>
              <a:rPr lang="en-US"/>
              <a:t>Chemotherapy</a:t>
            </a:r>
            <a:endParaRPr lang="zh-CN"/>
          </a:p>
          <a:p>
            <a:pPr algn="ctr" rtl="0">
              <a:defRPr/>
            </a:pPr>
            <a:endParaRPr lang="en-US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6.5335958005249384E-2"/>
          <c:y val="0.12626359758127662"/>
          <c:w val="0.70674035937815805"/>
          <c:h val="0.74598471651220877"/>
        </c:manualLayout>
      </c:layout>
      <c:scatterChart>
        <c:scatterStyle val="lineMarker"/>
        <c:varyColors val="0"/>
        <c:ser>
          <c:idx val="0"/>
          <c:order val="0"/>
          <c:tx>
            <c:v>Trial OS</c:v>
          </c:tx>
          <c:spPr>
            <a:ln w="28575">
              <a:solidFill>
                <a:schemeClr val="accent1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F$34:$F$58</c:f>
              <c:numCache>
                <c:formatCode>General</c:formatCode>
                <c:ptCount val="25"/>
                <c:pt idx="0">
                  <c:v>1</c:v>
                </c:pt>
                <c:pt idx="1">
                  <c:v>0.99</c:v>
                </c:pt>
                <c:pt idx="2">
                  <c:v>0.96</c:v>
                </c:pt>
                <c:pt idx="3">
                  <c:v>0.93</c:v>
                </c:pt>
                <c:pt idx="4">
                  <c:v>0.88</c:v>
                </c:pt>
                <c:pt idx="5">
                  <c:v>0.83</c:v>
                </c:pt>
                <c:pt idx="6">
                  <c:v>0.78</c:v>
                </c:pt>
                <c:pt idx="7">
                  <c:v>0.71</c:v>
                </c:pt>
                <c:pt idx="8">
                  <c:v>0.66</c:v>
                </c:pt>
                <c:pt idx="9">
                  <c:v>0.62</c:v>
                </c:pt>
                <c:pt idx="10">
                  <c:v>0.59</c:v>
                </c:pt>
                <c:pt idx="11">
                  <c:v>0.54</c:v>
                </c:pt>
                <c:pt idx="12">
                  <c:v>0.49</c:v>
                </c:pt>
                <c:pt idx="13">
                  <c:v>0.45</c:v>
                </c:pt>
                <c:pt idx="14">
                  <c:v>0.42</c:v>
                </c:pt>
                <c:pt idx="15">
                  <c:v>0.38</c:v>
                </c:pt>
                <c:pt idx="16">
                  <c:v>0.37</c:v>
                </c:pt>
                <c:pt idx="17">
                  <c:v>0.32</c:v>
                </c:pt>
                <c:pt idx="18">
                  <c:v>0.28999999999999998</c:v>
                </c:pt>
                <c:pt idx="19">
                  <c:v>0.28000000000000003</c:v>
                </c:pt>
                <c:pt idx="20">
                  <c:v>0.27</c:v>
                </c:pt>
                <c:pt idx="21">
                  <c:v>0.26</c:v>
                </c:pt>
                <c:pt idx="22">
                  <c:v>0.22</c:v>
                </c:pt>
                <c:pt idx="23">
                  <c:v>0.22</c:v>
                </c:pt>
                <c:pt idx="24">
                  <c:v>0.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504-4F59-84B2-2AC27D0F4EC9}"/>
            </c:ext>
          </c:extLst>
        </c:ser>
        <c:ser>
          <c:idx val="1"/>
          <c:order val="1"/>
          <c:tx>
            <c:v>Model OS</c:v>
          </c:tx>
          <c:spPr>
            <a:ln w="28575">
              <a:solidFill>
                <a:srgbClr val="002060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G$34:$G$58</c:f>
              <c:numCache>
                <c:formatCode>General</c:formatCode>
                <c:ptCount val="25"/>
                <c:pt idx="0">
                  <c:v>1</c:v>
                </c:pt>
                <c:pt idx="1">
                  <c:v>0.97810268031703895</c:v>
                </c:pt>
                <c:pt idx="2">
                  <c:v>0.94665442160350333</c:v>
                </c:pt>
                <c:pt idx="3">
                  <c:v>0.90840462094230312</c:v>
                </c:pt>
                <c:pt idx="4">
                  <c:v>0.86555056299769517</c:v>
                </c:pt>
                <c:pt idx="5">
                  <c:v>0.81983573885732541</c:v>
                </c:pt>
                <c:pt idx="6">
                  <c:v>0.77263160012443888</c:v>
                </c:pt>
                <c:pt idx="7">
                  <c:v>0.72500545909139924</c:v>
                </c:pt>
                <c:pt idx="8">
                  <c:v>0.67777680936457152</c:v>
                </c:pt>
                <c:pt idx="9">
                  <c:v>0.63156397446130197</c:v>
                </c:pt>
                <c:pt idx="10">
                  <c:v>0.58682268362172163</c:v>
                </c:pt>
                <c:pt idx="11">
                  <c:v>0.54387791507605576</c:v>
                </c:pt>
                <c:pt idx="12">
                  <c:v>0.5029501294566201</c:v>
                </c:pt>
                <c:pt idx="13">
                  <c:v>0.4641768333551744</c:v>
                </c:pt>
                <c:pt idx="14">
                  <c:v>0.42763025965585699</c:v>
                </c:pt>
                <c:pt idx="15">
                  <c:v>0.39333182255454346</c:v>
                </c:pt>
                <c:pt idx="16">
                  <c:v>0.36126389717952639</c:v>
                </c:pt>
                <c:pt idx="17">
                  <c:v>0.33137938315079762</c:v>
                </c:pt>
                <c:pt idx="18">
                  <c:v>0.30360943547502134</c:v>
                </c:pt>
                <c:pt idx="19">
                  <c:v>0.27786968253092298</c:v>
                </c:pt>
                <c:pt idx="20">
                  <c:v>0.25406519758722823</c:v>
                </c:pt>
                <c:pt idx="21">
                  <c:v>0.23209444565718901</c:v>
                </c:pt>
                <c:pt idx="22">
                  <c:v>0.21185239013810037</c:v>
                </c:pt>
                <c:pt idx="23">
                  <c:v>0.193232912440605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504-4F59-84B2-2AC27D0F4EC9}"/>
            </c:ext>
          </c:extLst>
        </c:ser>
        <c:ser>
          <c:idx val="2"/>
          <c:order val="2"/>
          <c:tx>
            <c:v>Trial PFS</c:v>
          </c:tx>
          <c:spPr>
            <a:ln w="28575">
              <a:solidFill>
                <a:schemeClr val="accent2"/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I$34:$I$58</c:f>
              <c:numCache>
                <c:formatCode>General</c:formatCode>
                <c:ptCount val="25"/>
                <c:pt idx="0">
                  <c:v>1</c:v>
                </c:pt>
                <c:pt idx="1">
                  <c:v>0.97</c:v>
                </c:pt>
                <c:pt idx="2">
                  <c:v>0.67</c:v>
                </c:pt>
                <c:pt idx="3">
                  <c:v>0.62</c:v>
                </c:pt>
                <c:pt idx="4">
                  <c:v>0.47</c:v>
                </c:pt>
                <c:pt idx="5">
                  <c:v>0.44</c:v>
                </c:pt>
                <c:pt idx="6">
                  <c:v>0.36</c:v>
                </c:pt>
                <c:pt idx="7">
                  <c:v>0.31</c:v>
                </c:pt>
                <c:pt idx="8">
                  <c:v>0.22</c:v>
                </c:pt>
                <c:pt idx="9">
                  <c:v>0.19</c:v>
                </c:pt>
                <c:pt idx="10">
                  <c:v>0.15</c:v>
                </c:pt>
                <c:pt idx="11">
                  <c:v>0.15</c:v>
                </c:pt>
                <c:pt idx="12">
                  <c:v>0.13</c:v>
                </c:pt>
                <c:pt idx="13">
                  <c:v>0.12</c:v>
                </c:pt>
                <c:pt idx="14">
                  <c:v>0.1</c:v>
                </c:pt>
                <c:pt idx="15">
                  <c:v>0.09</c:v>
                </c:pt>
                <c:pt idx="16">
                  <c:v>0.09</c:v>
                </c:pt>
                <c:pt idx="17">
                  <c:v>0.08</c:v>
                </c:pt>
                <c:pt idx="18">
                  <c:v>7.0000000000000007E-2</c:v>
                </c:pt>
                <c:pt idx="19">
                  <c:v>0.03</c:v>
                </c:pt>
                <c:pt idx="20">
                  <c:v>0.03</c:v>
                </c:pt>
                <c:pt idx="21">
                  <c:v>0.03</c:v>
                </c:pt>
                <c:pt idx="22">
                  <c:v>0.03</c:v>
                </c:pt>
                <c:pt idx="23">
                  <c:v>0.03</c:v>
                </c:pt>
                <c:pt idx="24">
                  <c:v>0.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504-4F59-84B2-2AC27D0F4EC9}"/>
            </c:ext>
          </c:extLst>
        </c:ser>
        <c:ser>
          <c:idx val="3"/>
          <c:order val="3"/>
          <c:tx>
            <c:v>Model PFS</c:v>
          </c:tx>
          <c:spPr>
            <a:ln w="28575">
              <a:solidFill>
                <a:schemeClr val="accent2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TrialCalibration!$E$34:$E$58</c:f>
              <c:numCache>
                <c:formatCode>General</c:formatCode>
                <c:ptCount val="2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</c:numCache>
            </c:numRef>
          </c:xVal>
          <c:yVal>
            <c:numRef>
              <c:f>TrialCalibration!$J$34:$J$58</c:f>
              <c:numCache>
                <c:formatCode>General</c:formatCode>
                <c:ptCount val="25"/>
                <c:pt idx="0">
                  <c:v>1</c:v>
                </c:pt>
                <c:pt idx="1">
                  <c:v>0.84274602304975421</c:v>
                </c:pt>
                <c:pt idx="2">
                  <c:v>0.71022085936617674</c:v>
                </c:pt>
                <c:pt idx="3">
                  <c:v>0.59853580471782419</c:v>
                </c:pt>
                <c:pt idx="4">
                  <c:v>0.50441366907883056</c:v>
                </c:pt>
                <c:pt idx="5">
                  <c:v>0.42509261358811917</c:v>
                </c:pt>
                <c:pt idx="6">
                  <c:v>0.35824510952921329</c:v>
                </c:pt>
                <c:pt idx="7">
                  <c:v>0.30190964133276804</c:v>
                </c:pt>
                <c:pt idx="8">
                  <c:v>0.25443314955356794</c:v>
                </c:pt>
                <c:pt idx="9">
                  <c:v>0.21442252491829272</c:v>
                </c:pt>
                <c:pt idx="10">
                  <c:v>0.180703730127178</c:v>
                </c:pt>
                <c:pt idx="11">
                  <c:v>0.15228734991493531</c:v>
                </c:pt>
                <c:pt idx="12">
                  <c:v>0.12833955850159803</c:v>
                </c:pt>
                <c:pt idx="13">
                  <c:v>0.108157652527183</c:v>
                </c:pt>
                <c:pt idx="14">
                  <c:v>9.1149431529680663E-2</c:v>
                </c:pt>
                <c:pt idx="15">
                  <c:v>7.6815820924884246E-2</c:v>
                </c:pt>
                <c:pt idx="16">
                  <c:v>6.4736227591748283E-2</c:v>
                </c:pt>
                <c:pt idx="17">
                  <c:v>5.4556198350189627E-2</c:v>
                </c:pt>
                <c:pt idx="18">
                  <c:v>4.5977019192335863E-2</c:v>
                </c:pt>
                <c:pt idx="19">
                  <c:v>3.8746950076023266E-2</c:v>
                </c:pt>
                <c:pt idx="20">
                  <c:v>3.2653838081875976E-2</c:v>
                </c:pt>
                <c:pt idx="21">
                  <c:v>2.7518892180811591E-2</c:v>
                </c:pt>
                <c:pt idx="22">
                  <c:v>2.3191436944113943E-2</c:v>
                </c:pt>
                <c:pt idx="23">
                  <c:v>1.954449125346116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504-4F59-84B2-2AC27D0F4E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7534416"/>
        <c:axId val="367535592"/>
      </c:scatterChart>
      <c:valAx>
        <c:axId val="367534416"/>
        <c:scaling>
          <c:orientation val="minMax"/>
          <c:max val="28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dirty="0"/>
                  <a:t>Months</a:t>
                </a:r>
                <a:endParaRPr lang="zh-CN" altLang="en-US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367535592"/>
        <c:crossesAt val="0"/>
        <c:crossBetween val="midCat"/>
      </c:valAx>
      <c:valAx>
        <c:axId val="36753559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crossAx val="3675344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9386330979690822"/>
          <c:y val="0.34502173711692313"/>
          <c:w val="0.17578470274539335"/>
          <c:h val="0.311794484387482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3ED9EF-577E-4A59-8861-2763D0E04C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2971EB1-D5C1-43FB-AD9D-B29CACBAFD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597376-0CAF-43CB-9E2E-7DB565657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404780-BEB9-4B99-ADBF-F069500BF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7AA34B-E11A-4969-B74C-266FBF886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4559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1E3A5D-0A4A-49AF-89EF-4A514339E6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6E8E51E-13BA-40F1-B551-7B66F2BF7D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362847-8405-44CC-B79D-0F97155E4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E750DA3-B51E-489D-8231-6C5CEE4E3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0A32A41-E2A3-47C6-A5D3-06505AEFF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6825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A6D8D91-54E5-4A84-977E-06B7BE5287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8B7D144-CF8A-4A95-88EA-398EC32D71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E1E722F-51B3-4F27-B80A-DB1184F0D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965BF8-8E45-4EED-AFAF-E7DB94E79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0D559F-A225-43CC-A20C-D488C6721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2230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C7FD66-330E-4EF1-9797-0BC6697589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2F9D143-DDC7-42F7-9C80-89AEBDAE8C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38B3A77-7EF0-44AC-93B4-6EFDC42FC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CC6A9F-7767-4CBD-9B75-01021A4DE9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7C3EC7-CB68-4D34-AD3F-DCE88E4E1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592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0161FE-BF3C-4E44-91A1-D2004474F4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8B6335A-D1A0-48D1-AA40-C42AEB7D95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7CD98C-3ABA-42A4-B7AB-899CDCADA3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B9C20F-4A90-49B2-AB39-BD6FA02A2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550C82-A304-4F85-B44C-B5761027B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0193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4123BA-43F0-4D5A-B465-3E05F6EAD1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BF385B4-2992-451B-8822-6FEBCCA1B8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A6D420A-3934-4D4B-9957-F04AC5EED6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2A309D6-A8C4-4780-941E-6B864CBD8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D141A7-2E0C-414C-8AF1-5BD302873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5AE60F8-0EC1-4B3B-950F-C75163B2D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2763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1FE4EA-4656-4FC7-9097-7354432676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46B539-D291-47D6-BBE2-4476A75979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2F7B46D-C77F-4B3C-A55B-B0D6A19013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407ADD3-0704-4CD7-82B6-67138E082D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1A11207-AAE8-481B-9085-767E48CD1B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2C18DBF-BFE5-44AD-9A08-0DF3D9F4B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7E15DA9-9851-41A7-BCCC-288D1B614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41237C1-965D-4662-8035-A54806657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9763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0FD97B-3983-4266-8914-44116B3B4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168D503-0D2C-49CE-9225-7439F1D3E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49605EF-0FF3-4A60-9C22-C9F828840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55B4709-416F-4644-87BF-F04777BB2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2496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429C368-1A19-432F-9BD6-C677A1400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121121C-F746-471A-92A7-71269F6F7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E94F7DF-2AE6-4019-9BC8-235B0803F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6567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346CDD-3550-410B-A314-58F7AE314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AE1AD7-7869-4F23-B7BA-D4B42E4F8C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18D6D17-1CD7-4D92-B7C7-E5AE059D2F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F81579F-9263-4894-93B5-11D0BA0E08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9A69861-8FA3-4159-BD78-83764AB99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B7E1908-3409-433F-9BC4-0E02AAD49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384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393F14-8256-4B75-A1EA-3F675F0F04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0A94FB5-243A-4DEF-881D-84B18FB4A9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826C0DC-D948-490D-B72F-11742988A0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01F676A-1770-4764-B5AB-7F906BDA2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330FAF0-07C7-446E-ABA4-CA6C731F06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427B998-346E-4AAD-AB94-B19B3F3D1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9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4C0DE87-BB25-4A0D-8425-9E928BBBA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89EF0C8-EC15-427F-A4F7-22184DD8AC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F153F6-EA8E-40F1-824E-88C9A86757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547158-B80B-45AE-87CA-F1A1851009C3}" type="datetimeFigureOut">
              <a:rPr lang="zh-CN" altLang="en-US" smtClean="0"/>
              <a:t>2022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8E5F76-6DC7-4CC5-9F9E-8530BEB56C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5190BF8-95CB-40CC-94C0-1ED05BD1A3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5EA828-9DEF-40D7-B9B3-5B463995B2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3054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1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5107445"/>
              </p:ext>
            </p:extLst>
          </p:nvPr>
        </p:nvGraphicFramePr>
        <p:xfrm>
          <a:off x="45950" y="647891"/>
          <a:ext cx="5890758" cy="3028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3B63C25E-F57E-4993-82AD-0805679B74BD}"/>
              </a:ext>
            </a:extLst>
          </p:cNvPr>
          <p:cNvSpPr txBox="1"/>
          <p:nvPr/>
        </p:nvSpPr>
        <p:spPr>
          <a:xfrm>
            <a:off x="0" y="170882"/>
            <a:ext cx="5128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Parametric model curves in all population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Chart 1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5755487"/>
              </p:ext>
            </p:extLst>
          </p:nvPr>
        </p:nvGraphicFramePr>
        <p:xfrm>
          <a:off x="6028608" y="647891"/>
          <a:ext cx="6063752" cy="3028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EF3AFB6F-0CC5-A142-A078-744AF5C48821}"/>
              </a:ext>
            </a:extLst>
          </p:cNvPr>
          <p:cNvSpPr txBox="1"/>
          <p:nvPr/>
        </p:nvSpPr>
        <p:spPr>
          <a:xfrm>
            <a:off x="179203" y="57610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6239CDA-9E30-2D44-BEE1-BBD45D135326}"/>
              </a:ext>
            </a:extLst>
          </p:cNvPr>
          <p:cNvSpPr txBox="1"/>
          <p:nvPr/>
        </p:nvSpPr>
        <p:spPr>
          <a:xfrm>
            <a:off x="6409017" y="54270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59017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5450EFA-9207-4A13-AD5C-47B6E46E16EF}"/>
              </a:ext>
            </a:extLst>
          </p:cNvPr>
          <p:cNvSpPr txBox="1"/>
          <p:nvPr/>
        </p:nvSpPr>
        <p:spPr>
          <a:xfrm>
            <a:off x="179203" y="195623"/>
            <a:ext cx="5577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Parametric model curves in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MMR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Chart 1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7567825"/>
              </p:ext>
            </p:extLst>
          </p:nvPr>
        </p:nvGraphicFramePr>
        <p:xfrm>
          <a:off x="179203" y="710622"/>
          <a:ext cx="5631393" cy="27800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1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2855732"/>
              </p:ext>
            </p:extLst>
          </p:nvPr>
        </p:nvGraphicFramePr>
        <p:xfrm>
          <a:off x="6573285" y="726779"/>
          <a:ext cx="5439512" cy="27639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文本框 6">
            <a:extLst>
              <a:ext uri="{FF2B5EF4-FFF2-40B4-BE49-F238E27FC236}">
                <a16:creationId xmlns:a16="http://schemas.microsoft.com/office/drawing/2014/main" id="{ACD42ED0-B8AA-5D42-9606-B898A6CCAD89}"/>
              </a:ext>
            </a:extLst>
          </p:cNvPr>
          <p:cNvSpPr txBox="1"/>
          <p:nvPr/>
        </p:nvSpPr>
        <p:spPr>
          <a:xfrm>
            <a:off x="179203" y="57610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72FA553-8010-8347-9957-E197B9CBCBBF}"/>
              </a:ext>
            </a:extLst>
          </p:cNvPr>
          <p:cNvSpPr txBox="1"/>
          <p:nvPr/>
        </p:nvSpPr>
        <p:spPr>
          <a:xfrm>
            <a:off x="6409017" y="54270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7160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</TotalTime>
  <Words>36</Words>
  <Application>Microsoft Macintosh PowerPoint</Application>
  <PresentationFormat>宽屏</PresentationFormat>
  <Paragraphs>1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</dc:creator>
  <cp:lastModifiedBy>Happy</cp:lastModifiedBy>
  <cp:revision>6</cp:revision>
  <dcterms:created xsi:type="dcterms:W3CDTF">2022-02-07T09:40:14Z</dcterms:created>
  <dcterms:modified xsi:type="dcterms:W3CDTF">2022-02-22T06:50:54Z</dcterms:modified>
</cp:coreProperties>
</file>